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43080" y="685440"/>
            <a:ext cx="2571840" cy="3429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938E7D7-2DEF-4C1A-A7DD-22F9BE38B983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0CD4935-14CD-44E8-ADCC-AD86AD475984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67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00E9BA-3BCD-4109-B095-D8325F632CE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D80721-D96C-45D9-88C4-67741747FB2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EA6CB6-B5E5-4FB8-8F05-939D92BF4D1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B3F5B6-11E6-4374-A03D-52214256564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72E86D-3917-4BC3-9578-7205F24352B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F73877-F1B1-4124-9E66-ED4000A7994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0C5810-133F-4514-AAF8-AD0EDA4880A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9CB89F-F296-4DAA-9594-5CFDE1F367A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AB9DCE-86BA-4922-BA65-EBBBFDED30A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B4728D-89D5-4298-B651-580313337F3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1580E2-22CE-4375-8B5B-9B12EAD6BC0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195B63-E241-45E6-BCBE-4CF48431F7F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0F20DEC-4A2A-4C9D-82CA-C3B0597A47D3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 Box 2"/>
          <p:cNvSpPr/>
          <p:nvPr/>
        </p:nvSpPr>
        <p:spPr>
          <a:xfrm>
            <a:off x="1447920" y="1676520"/>
            <a:ext cx="3695760" cy="6415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De-identified frozen breast cancer biopsies with high quality structural integrity that were previously used in clinical assays of ER &amp; P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 Box 3"/>
          <p:cNvSpPr/>
          <p:nvPr/>
        </p:nvSpPr>
        <p:spPr>
          <a:xfrm>
            <a:off x="76320" y="2895480"/>
            <a:ext cx="2971800" cy="8240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Requirements: Invasive ductal carcinoma, female patient, age &gt;18, Stage 1-3, frozen tissue in Biorepository, clinical records in Databas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Line 4"/>
          <p:cNvSpPr/>
          <p:nvPr/>
        </p:nvSpPr>
        <p:spPr>
          <a:xfrm>
            <a:off x="3371760" y="2590920"/>
            <a:ext cx="0" cy="132084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 Box 5"/>
          <p:cNvSpPr/>
          <p:nvPr/>
        </p:nvSpPr>
        <p:spPr>
          <a:xfrm>
            <a:off x="1990800" y="4003560"/>
            <a:ext cx="2504880" cy="459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opulation: Total RNA from each of  225 breast specimens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 Box 6"/>
          <p:cNvSpPr/>
          <p:nvPr/>
        </p:nvSpPr>
        <p:spPr>
          <a:xfrm>
            <a:off x="1066680" y="4813200"/>
            <a:ext cx="1847880" cy="6415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7 patients were never disease-free, not utilized in models of recurrence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Freeform 7"/>
          <p:cNvSpPr/>
          <p:nvPr/>
        </p:nvSpPr>
        <p:spPr>
          <a:xfrm>
            <a:off x="3048120" y="3251160"/>
            <a:ext cx="323640" cy="254160"/>
          </a:xfrm>
          <a:custGeom>
            <a:avLst/>
            <a:gdLst/>
            <a:ahLst/>
            <a:rect l="l" t="t" r="r" b="b"/>
            <a:pathLst>
              <a:path w="288" h="112">
                <a:moveTo>
                  <a:pt x="0" y="16"/>
                </a:moveTo>
                <a:cubicBezTo>
                  <a:pt x="48" y="8"/>
                  <a:pt x="96" y="0"/>
                  <a:pt x="144" y="16"/>
                </a:cubicBezTo>
                <a:cubicBezTo>
                  <a:pt x="192" y="32"/>
                  <a:pt x="264" y="96"/>
                  <a:pt x="288" y="112"/>
                </a:cubicBezTo>
              </a:path>
            </a:pathLst>
          </a:custGeom>
          <a:noFill/>
          <a:ln w="9360">
            <a:solidFill>
              <a:srgbClr val="000000"/>
            </a:solidFill>
            <a:round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Line 8"/>
          <p:cNvSpPr/>
          <p:nvPr/>
        </p:nvSpPr>
        <p:spPr>
          <a:xfrm>
            <a:off x="3371760" y="4622760"/>
            <a:ext cx="0" cy="12193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Freeform 9"/>
          <p:cNvSpPr/>
          <p:nvPr/>
        </p:nvSpPr>
        <p:spPr>
          <a:xfrm>
            <a:off x="2914560" y="4724280"/>
            <a:ext cx="457200" cy="507960"/>
          </a:xfrm>
          <a:custGeom>
            <a:avLst/>
            <a:gdLst/>
            <a:ahLst/>
            <a:rect l="l" t="t" r="r" b="b"/>
            <a:pathLst>
              <a:path w="384" h="240">
                <a:moveTo>
                  <a:pt x="384" y="0"/>
                </a:moveTo>
                <a:cubicBezTo>
                  <a:pt x="344" y="76"/>
                  <a:pt x="304" y="152"/>
                  <a:pt x="240" y="192"/>
                </a:cubicBezTo>
                <a:cubicBezTo>
                  <a:pt x="176" y="232"/>
                  <a:pt x="88" y="236"/>
                  <a:pt x="0" y="240"/>
                </a:cubicBezTo>
              </a:path>
            </a:pathLst>
          </a:custGeom>
          <a:noFill/>
          <a:ln w="9360">
            <a:solidFill>
              <a:srgbClr val="000000"/>
            </a:solidFill>
            <a:round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 Box 10"/>
          <p:cNvSpPr/>
          <p:nvPr/>
        </p:nvSpPr>
        <p:spPr>
          <a:xfrm>
            <a:off x="2514600" y="6134040"/>
            <a:ext cx="1657440" cy="8240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ub-population 2: 73 patients treated with surgery &amp; adjuvant hormone therapy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 Box 11"/>
          <p:cNvSpPr/>
          <p:nvPr/>
        </p:nvSpPr>
        <p:spPr>
          <a:xfrm>
            <a:off x="743040" y="6146640"/>
            <a:ext cx="1657440" cy="6415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ub-population 1: 56 patients treated with surgery alone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 Box 12"/>
          <p:cNvSpPr/>
          <p:nvPr/>
        </p:nvSpPr>
        <p:spPr>
          <a:xfrm>
            <a:off x="4267080" y="6146640"/>
            <a:ext cx="2133720" cy="6415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ub-population 3: 96 patients treated with surgery &amp; chemo/radiation therapy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Line 13"/>
          <p:cNvSpPr/>
          <p:nvPr/>
        </p:nvSpPr>
        <p:spPr>
          <a:xfrm>
            <a:off x="1657440" y="5842080"/>
            <a:ext cx="34862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Line 14"/>
          <p:cNvSpPr/>
          <p:nvPr/>
        </p:nvSpPr>
        <p:spPr>
          <a:xfrm>
            <a:off x="1657440" y="5842080"/>
            <a:ext cx="0" cy="20304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Line 15"/>
          <p:cNvSpPr/>
          <p:nvPr/>
        </p:nvSpPr>
        <p:spPr>
          <a:xfrm>
            <a:off x="3371760" y="5842080"/>
            <a:ext cx="0" cy="20304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Line 16"/>
          <p:cNvSpPr/>
          <p:nvPr/>
        </p:nvSpPr>
        <p:spPr>
          <a:xfrm>
            <a:off x="5143680" y="5842080"/>
            <a:ext cx="0" cy="20304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 Box 18"/>
          <p:cNvSpPr/>
          <p:nvPr/>
        </p:nvSpPr>
        <p:spPr>
          <a:xfrm>
            <a:off x="708120" y="762120"/>
            <a:ext cx="2206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Supplemental Figure 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 Box 19"/>
          <p:cNvSpPr/>
          <p:nvPr/>
        </p:nvSpPr>
        <p:spPr>
          <a:xfrm>
            <a:off x="0" y="8031240"/>
            <a:ext cx="6858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upplemental Figure 1.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 REMARK diagram illustrating patient selection utilized in this study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8-26T17:35:23Z</dcterms:created>
  <dc:creator>Alan</dc:creator>
  <dc:description/>
  <dc:language>en-US</dc:language>
  <cp:lastModifiedBy>jlwitt01</cp:lastModifiedBy>
  <dcterms:modified xsi:type="dcterms:W3CDTF">2012-10-15T19:01:54Z</dcterms:modified>
  <cp:revision>21</cp:revision>
  <dc:subject/>
  <dc:title>Slide 1</dc:title>
</cp:coreProperties>
</file>